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93"/>
    <a:srgbClr val="0432FF"/>
    <a:srgbClr val="0099FF"/>
    <a:srgbClr val="6666FF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A4687CA-CB19-5FF8-0876-74945C6DD7C2}" v="6" dt="2024-10-17T13:50:46.3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34" autoAdjust="0"/>
    <p:restoredTop sz="89133" autoAdjust="0"/>
  </p:normalViewPr>
  <p:slideViewPr>
    <p:cSldViewPr>
      <p:cViewPr varScale="1">
        <p:scale>
          <a:sx n="84" d="100"/>
          <a:sy n="84" d="100"/>
        </p:scale>
        <p:origin x="349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INARA VALLEJO ILLARAMENDI" userId="S::ainara.vallejo@ehu.eus::25301b5b-d7a3-4a2f-8c13-b02cf052f451" providerId="AD" clId="Web-{CA4687CA-CB19-5FF8-0876-74945C6DD7C2}"/>
    <pc:docChg chg="modSld">
      <pc:chgData name="AINARA VALLEJO ILLARAMENDI" userId="S::ainara.vallejo@ehu.eus::25301b5b-d7a3-4a2f-8c13-b02cf052f451" providerId="AD" clId="Web-{CA4687CA-CB19-5FF8-0876-74945C6DD7C2}" dt="2024-10-17T13:50:46.356" v="2" actId="20577"/>
      <pc:docMkLst>
        <pc:docMk/>
      </pc:docMkLst>
      <pc:sldChg chg="modSp">
        <pc:chgData name="AINARA VALLEJO ILLARAMENDI" userId="S::ainara.vallejo@ehu.eus::25301b5b-d7a3-4a2f-8c13-b02cf052f451" providerId="AD" clId="Web-{CA4687CA-CB19-5FF8-0876-74945C6DD7C2}" dt="2024-10-17T13:50:46.356" v="2" actId="20577"/>
        <pc:sldMkLst>
          <pc:docMk/>
          <pc:sldMk cId="3882811369" sldId="269"/>
        </pc:sldMkLst>
        <pc:spChg chg="mod">
          <ac:chgData name="AINARA VALLEJO ILLARAMENDI" userId="S::ainara.vallejo@ehu.eus::25301b5b-d7a3-4a2f-8c13-b02cf052f451" providerId="AD" clId="Web-{CA4687CA-CB19-5FF8-0876-74945C6DD7C2}" dt="2024-10-17T13:50:46.356" v="2" actId="20577"/>
          <ac:spMkLst>
            <pc:docMk/>
            <pc:sldMk cId="3882811369" sldId="269"/>
            <ac:spMk id="2" creationId="{FA224C7D-7940-A54C-8741-2C07501647D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95FE5E-4CF1-4147-A7E9-458E8C4EA635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E99E51-74DE-4A55-87DF-BE48CBADAC0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8936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E99E51-74DE-4A55-87DF-BE48CBADAC0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7697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5041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3477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5499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4454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3455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7468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741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2671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8667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6727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3393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78A0B-CF47-4A6B-9E83-5223B5FF95F0}" type="datetimeFigureOut">
              <a:rPr lang="es-ES" smtClean="0"/>
              <a:t>22/11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3230A-D887-4DB4-A053-C321021331F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4370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Picture 4" descr="Chart&#10;&#10;Description automatically generated">
            <a:extLst>
              <a:ext uri="{FF2B5EF4-FFF2-40B4-BE49-F238E27FC236}">
                <a16:creationId xmlns:a16="http://schemas.microsoft.com/office/drawing/2014/main" id="{B6A577E6-A70D-B447-8F82-382DF7C205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875" b="5569"/>
          <a:stretch/>
        </p:blipFill>
        <p:spPr>
          <a:xfrm>
            <a:off x="1772816" y="1115616"/>
            <a:ext cx="2869818" cy="2160000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FA224C7D-7940-A54C-8741-2C07501647DE}"/>
              </a:ext>
            </a:extLst>
          </p:cNvPr>
          <p:cNvSpPr/>
          <p:nvPr/>
        </p:nvSpPr>
        <p:spPr>
          <a:xfrm>
            <a:off x="188641" y="3851920"/>
            <a:ext cx="6439248" cy="861774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0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: AHK rescue splicing events in aging related genes.</a:t>
            </a:r>
          </a:p>
          <a:p>
            <a:pPr algn="just"/>
            <a:r>
              <a:rPr lang="en-US" sz="1000" dirty="0">
                <a:latin typeface="Times New Roman"/>
                <a:ea typeface="Times New Roman" panose="02020603050405020304" pitchFamily="18" charset="0"/>
                <a:cs typeface="Times New Roman"/>
              </a:rPr>
              <a:t>Each column represents a comparison between samples status. Color represents inclusion(yellow) or exclusion (green) of the event; shape represent type of event: exon skipping (circle), or intron retention (triangle) and size represents the absolute value of the difference of Percentage of Splice-In (</a:t>
            </a:r>
            <a:r>
              <a:rPr lang="en-US" sz="10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dPSI</a:t>
            </a:r>
            <a:r>
              <a:rPr lang="en-US" sz="1000" dirty="0">
                <a:latin typeface="Times New Roman"/>
                <a:ea typeface="Times New Roman" panose="02020603050405020304" pitchFamily="18" charset="0"/>
                <a:cs typeface="Times New Roman"/>
              </a:rPr>
              <a:t>) for each comparison. For the analysis, the splicing events were filtered by at least 10 reads and a </a:t>
            </a:r>
            <a:r>
              <a:rPr lang="en-US" sz="10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dPSI</a:t>
            </a:r>
            <a:r>
              <a:rPr lang="en-US" sz="1000" dirty="0">
                <a:latin typeface="Times New Roman"/>
                <a:ea typeface="Times New Roman" panose="02020603050405020304" pitchFamily="18" charset="0"/>
                <a:cs typeface="Times New Roman"/>
              </a:rPr>
              <a:t> of 15%. The XYLB gene was added as negative control.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4" name="Rectángulo 3"/>
          <p:cNvSpPr/>
          <p:nvPr/>
        </p:nvSpPr>
        <p:spPr>
          <a:xfrm>
            <a:off x="3046047" y="3235206"/>
            <a:ext cx="144016" cy="144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" name="CuadroTexto 2"/>
          <p:cNvSpPr txBox="1"/>
          <p:nvPr/>
        </p:nvSpPr>
        <p:spPr>
          <a:xfrm>
            <a:off x="2938035" y="3165593"/>
            <a:ext cx="3600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/>
              <a:t>MP2</a:t>
            </a:r>
          </a:p>
        </p:txBody>
      </p:sp>
      <p:sp>
        <p:nvSpPr>
          <p:cNvPr id="7" name="Rectángulo 6"/>
          <p:cNvSpPr/>
          <p:nvPr/>
        </p:nvSpPr>
        <p:spPr>
          <a:xfrm>
            <a:off x="3773050" y="3229510"/>
            <a:ext cx="144016" cy="144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" name="CuadroTexto 7"/>
          <p:cNvSpPr txBox="1"/>
          <p:nvPr/>
        </p:nvSpPr>
        <p:spPr>
          <a:xfrm>
            <a:off x="3665038" y="3165593"/>
            <a:ext cx="3600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/>
              <a:t>MP2</a:t>
            </a:r>
          </a:p>
        </p:txBody>
      </p:sp>
    </p:spTree>
    <p:extLst>
      <p:ext uri="{BB962C8B-B14F-4D97-AF65-F5344CB8AC3E}">
        <p14:creationId xmlns:p14="http://schemas.microsoft.com/office/powerpoint/2010/main" val="38828113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68</TotalTime>
  <Words>107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KEL GARCIA PUGA</dc:creator>
  <cp:lastModifiedBy>MDPI</cp:lastModifiedBy>
  <cp:revision>153</cp:revision>
  <dcterms:created xsi:type="dcterms:W3CDTF">2019-07-04T08:07:56Z</dcterms:created>
  <dcterms:modified xsi:type="dcterms:W3CDTF">2024-11-22T10:23:02Z</dcterms:modified>
</cp:coreProperties>
</file>